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tags/tag1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6" d="100"/>
          <a:sy n="116" d="100"/>
        </p:scale>
        <p:origin x="2070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4B7623-63E7-487D-973E-53E6C372B7BE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51D87F-BB39-43FA-B991-5F9C768E80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0338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151D87F-BB39-43FA-B991-5F9C768E80A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1996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876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2383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64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5393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268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820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41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731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941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164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398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829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6123582"/>
              </p:ext>
            </p:extLst>
          </p:nvPr>
        </p:nvGraphicFramePr>
        <p:xfrm>
          <a:off x="4267200" y="181728"/>
          <a:ext cx="2362200" cy="48728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4" name="SPW 13.0 Graph" r:id="rId4" imgW="3642529" imgH="7513151" progId="SigmaPlotGraphicObject.12">
                  <p:embed/>
                </p:oleObj>
              </mc:Choice>
              <mc:Fallback>
                <p:oleObj name="SPW 13.0 Graph" r:id="rId4" imgW="3642529" imgH="7513151" progId="SigmaPlotGraphicObjec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267200" y="181728"/>
                        <a:ext cx="2362200" cy="48728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0543676"/>
              </p:ext>
            </p:extLst>
          </p:nvPr>
        </p:nvGraphicFramePr>
        <p:xfrm>
          <a:off x="1447800" y="181729"/>
          <a:ext cx="2402173" cy="4872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5" name="SPW 13.0 Graph" r:id="rId6" imgW="3704940" imgH="7513151" progId="SigmaPlotGraphicObject.12">
                  <p:embed/>
                </p:oleObj>
              </mc:Choice>
              <mc:Fallback>
                <p:oleObj name="SPW 13.0 Graph" r:id="rId6" imgW="3704940" imgH="7513151" progId="SigmaPlotGraphicObjec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447800" y="181729"/>
                        <a:ext cx="2402173" cy="4872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402975" y="165309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191000" y="160020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295400" y="4572000"/>
            <a:ext cx="70534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S4 Fig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 effect of adipose LPP3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xpression on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ver lipi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mpositio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 Mice were f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at diet (HFD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fo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8 weeks, at which tim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iver was collected from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lpp3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lang="en-US" sz="12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; black symbols) and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P2-Cre/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lpp3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Δ; open symbols) mic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or measurement of the indicated lipids by HPLC electrospray ionization tandem mas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pectrometry, as described in the text, and total lipid levels ar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esented as mean ±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D. SM = sphingomyelin; S1P = sphingosine-1-phosphate; DH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hydrosphingosin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438400" y="2133600"/>
            <a:ext cx="4572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2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   </a:t>
            </a:r>
            <a:endParaRPr lang="en-US" sz="12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257800" y="2133599"/>
            <a:ext cx="4572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2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   </a:t>
            </a:r>
            <a:endParaRPr lang="en-US" sz="12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96735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</TotalTime>
  <Words>98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Symbol</vt:lpstr>
      <vt:lpstr>Office Theme</vt:lpstr>
      <vt:lpstr>SPW 13.0 Graph</vt:lpstr>
      <vt:lpstr>PowerPoint Presentation</vt:lpstr>
    </vt:vector>
  </TitlesOfParts>
  <Company>University of Kentuck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yth, Susan</dc:creator>
  <cp:lastModifiedBy>McMullen, Colleen</cp:lastModifiedBy>
  <cp:revision>16</cp:revision>
  <dcterms:created xsi:type="dcterms:W3CDTF">2017-09-11T17:11:52Z</dcterms:created>
  <dcterms:modified xsi:type="dcterms:W3CDTF">2018-05-31T16:39:03Z</dcterms:modified>
  <cp:contentStatus>Final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MarkAsFinal">
    <vt:bool>true</vt:bool>
  </property>
</Properties>
</file>